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0" r:id="rId2"/>
    <p:sldId id="266" r:id="rId3"/>
    <p:sldId id="264" r:id="rId4"/>
  </p:sldIdLst>
  <p:sldSz cx="6218238" cy="8229600"/>
  <p:notesSz cx="7010400" cy="9296400"/>
  <p:defaultTextStyle>
    <a:defPPr>
      <a:defRPr lang="en-US"/>
    </a:defPPr>
    <a:lvl1pPr marL="0" algn="l" defTabSz="8254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412716" algn="l" defTabSz="8254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825432" algn="l" defTabSz="8254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238148" algn="l" defTabSz="8254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1650864" algn="l" defTabSz="8254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2063581" algn="l" defTabSz="8254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2476296" algn="l" defTabSz="8254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2889011" algn="l" defTabSz="8254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3301727" algn="l" defTabSz="8254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tephanie Stotz" initials="SS" lastIdx="5" clrIdx="0"/>
  <p:cmAuthor id="1" name="Sylwia Wasiak" initials="SW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1A6B1"/>
    <a:srgbClr val="23C0D3"/>
    <a:srgbClr val="0000FF"/>
    <a:srgbClr val="D9D9D9"/>
    <a:srgbClr val="0D67A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075" autoAdjust="0"/>
  </p:normalViewPr>
  <p:slideViewPr>
    <p:cSldViewPr showGuides="1">
      <p:cViewPr>
        <p:scale>
          <a:sx n="100" d="100"/>
          <a:sy n="100" d="100"/>
        </p:scale>
        <p:origin x="-930" y="-72"/>
      </p:cViewPr>
      <p:guideLst>
        <p:guide orient="horz" pos="1642"/>
        <p:guide pos="3916"/>
        <p:guide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722C2A-62BF-49B0-A475-A8E3FC1A0A0F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89163" y="696913"/>
            <a:ext cx="263207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63DB61-E797-41DC-825E-8B98B2BB90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6289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2543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412716" algn="l" defTabSz="82543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825432" algn="l" defTabSz="82543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1238148" algn="l" defTabSz="82543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650864" algn="l" defTabSz="82543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2063581" algn="l" defTabSz="82543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2476296" algn="l" defTabSz="82543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2889011" algn="l" defTabSz="82543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3301727" algn="l" defTabSz="82543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6368" y="2556512"/>
            <a:ext cx="5285502" cy="176403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2736" y="4663440"/>
            <a:ext cx="4352767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27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254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381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508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635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762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890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017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B974A-4F3C-47B7-94AD-5246A51D4144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46560-B1B3-4A1F-A598-F19E307B53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769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B974A-4F3C-47B7-94AD-5246A51D4144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46560-B1B3-4A1F-A598-F19E307B53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854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381167" y="440056"/>
            <a:ext cx="1049328" cy="93611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33185" y="440056"/>
            <a:ext cx="3044346" cy="936117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B974A-4F3C-47B7-94AD-5246A51D4144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46560-B1B3-4A1F-A598-F19E307B53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611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B974A-4F3C-47B7-94AD-5246A51D4144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46560-B1B3-4A1F-A598-F19E307B53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86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198" y="5288281"/>
            <a:ext cx="5285502" cy="1634490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198" y="3488058"/>
            <a:ext cx="5285502" cy="1800224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1271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8254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3814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50864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6358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476296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88901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30172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B974A-4F3C-47B7-94AD-5246A51D4144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46560-B1B3-4A1F-A598-F19E307B53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496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33184" y="2560321"/>
            <a:ext cx="2046837" cy="7240906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83658" y="2560321"/>
            <a:ext cx="2046837" cy="7240906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B974A-4F3C-47B7-94AD-5246A51D4144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46560-B1B3-4A1F-A598-F19E307B53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6343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0912" y="329566"/>
            <a:ext cx="5596414" cy="13716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0913" y="1842135"/>
            <a:ext cx="2747468" cy="76771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2716" indent="0">
              <a:buNone/>
              <a:defRPr sz="1800" b="1"/>
            </a:lvl2pPr>
            <a:lvl3pPr marL="825432" indent="0">
              <a:buNone/>
              <a:defRPr sz="1500" b="1"/>
            </a:lvl3pPr>
            <a:lvl4pPr marL="1238148" indent="0">
              <a:buNone/>
              <a:defRPr sz="1400" b="1"/>
            </a:lvl4pPr>
            <a:lvl5pPr marL="1650864" indent="0">
              <a:buNone/>
              <a:defRPr sz="1400" b="1"/>
            </a:lvl5pPr>
            <a:lvl6pPr marL="2063581" indent="0">
              <a:buNone/>
              <a:defRPr sz="1400" b="1"/>
            </a:lvl6pPr>
            <a:lvl7pPr marL="2476296" indent="0">
              <a:buNone/>
              <a:defRPr sz="1400" b="1"/>
            </a:lvl7pPr>
            <a:lvl8pPr marL="2889011" indent="0">
              <a:buNone/>
              <a:defRPr sz="1400" b="1"/>
            </a:lvl8pPr>
            <a:lvl9pPr marL="3301727" indent="0">
              <a:buNone/>
              <a:defRPr sz="1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0913" y="2609850"/>
            <a:ext cx="2747468" cy="4741546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58779" y="1842135"/>
            <a:ext cx="2748547" cy="76771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2716" indent="0">
              <a:buNone/>
              <a:defRPr sz="1800" b="1"/>
            </a:lvl2pPr>
            <a:lvl3pPr marL="825432" indent="0">
              <a:buNone/>
              <a:defRPr sz="1500" b="1"/>
            </a:lvl3pPr>
            <a:lvl4pPr marL="1238148" indent="0">
              <a:buNone/>
              <a:defRPr sz="1400" b="1"/>
            </a:lvl4pPr>
            <a:lvl5pPr marL="1650864" indent="0">
              <a:buNone/>
              <a:defRPr sz="1400" b="1"/>
            </a:lvl5pPr>
            <a:lvl6pPr marL="2063581" indent="0">
              <a:buNone/>
              <a:defRPr sz="1400" b="1"/>
            </a:lvl6pPr>
            <a:lvl7pPr marL="2476296" indent="0">
              <a:buNone/>
              <a:defRPr sz="1400" b="1"/>
            </a:lvl7pPr>
            <a:lvl8pPr marL="2889011" indent="0">
              <a:buNone/>
              <a:defRPr sz="1400" b="1"/>
            </a:lvl8pPr>
            <a:lvl9pPr marL="3301727" indent="0">
              <a:buNone/>
              <a:defRPr sz="1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58779" y="2609850"/>
            <a:ext cx="2748547" cy="4741546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B974A-4F3C-47B7-94AD-5246A51D4144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46560-B1B3-4A1F-A598-F19E307B53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933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B974A-4F3C-47B7-94AD-5246A51D4144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46560-B1B3-4A1F-A598-F19E307B53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734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B974A-4F3C-47B7-94AD-5246A51D4144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46560-B1B3-4A1F-A598-F19E307B53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799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0913" y="327661"/>
            <a:ext cx="2045758" cy="139446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31159" y="327662"/>
            <a:ext cx="3476168" cy="7023736"/>
          </a:xfrm>
        </p:spPr>
        <p:txBody>
          <a:bodyPr/>
          <a:lstStyle>
            <a:lvl1pPr>
              <a:defRPr sz="2800"/>
            </a:lvl1pPr>
            <a:lvl2pPr>
              <a:defRPr sz="25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0913" y="1722122"/>
            <a:ext cx="2045758" cy="5629276"/>
          </a:xfrm>
        </p:spPr>
        <p:txBody>
          <a:bodyPr/>
          <a:lstStyle>
            <a:lvl1pPr marL="0" indent="0">
              <a:buNone/>
              <a:defRPr sz="1300"/>
            </a:lvl1pPr>
            <a:lvl2pPr marL="412716" indent="0">
              <a:buNone/>
              <a:defRPr sz="1100"/>
            </a:lvl2pPr>
            <a:lvl3pPr marL="825432" indent="0">
              <a:buNone/>
              <a:defRPr sz="900"/>
            </a:lvl3pPr>
            <a:lvl4pPr marL="1238148" indent="0">
              <a:buNone/>
              <a:defRPr sz="800"/>
            </a:lvl4pPr>
            <a:lvl5pPr marL="1650864" indent="0">
              <a:buNone/>
              <a:defRPr sz="800"/>
            </a:lvl5pPr>
            <a:lvl6pPr marL="2063581" indent="0">
              <a:buNone/>
              <a:defRPr sz="800"/>
            </a:lvl6pPr>
            <a:lvl7pPr marL="2476296" indent="0">
              <a:buNone/>
              <a:defRPr sz="800"/>
            </a:lvl7pPr>
            <a:lvl8pPr marL="2889011" indent="0">
              <a:buNone/>
              <a:defRPr sz="800"/>
            </a:lvl8pPr>
            <a:lvl9pPr marL="3301727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B974A-4F3C-47B7-94AD-5246A51D4144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46560-B1B3-4A1F-A598-F19E307B53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4685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8818" y="5760721"/>
            <a:ext cx="3730943" cy="680086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18818" y="735330"/>
            <a:ext cx="3730943" cy="4937760"/>
          </a:xfrm>
        </p:spPr>
        <p:txBody>
          <a:bodyPr/>
          <a:lstStyle>
            <a:lvl1pPr marL="0" indent="0">
              <a:buNone/>
              <a:defRPr sz="2800"/>
            </a:lvl1pPr>
            <a:lvl2pPr marL="412716" indent="0">
              <a:buNone/>
              <a:defRPr sz="2500"/>
            </a:lvl2pPr>
            <a:lvl3pPr marL="825432" indent="0">
              <a:buNone/>
              <a:defRPr sz="2200"/>
            </a:lvl3pPr>
            <a:lvl4pPr marL="1238148" indent="0">
              <a:buNone/>
              <a:defRPr sz="1800"/>
            </a:lvl4pPr>
            <a:lvl5pPr marL="1650864" indent="0">
              <a:buNone/>
              <a:defRPr sz="1800"/>
            </a:lvl5pPr>
            <a:lvl6pPr marL="2063581" indent="0">
              <a:buNone/>
              <a:defRPr sz="1800"/>
            </a:lvl6pPr>
            <a:lvl7pPr marL="2476296" indent="0">
              <a:buNone/>
              <a:defRPr sz="1800"/>
            </a:lvl7pPr>
            <a:lvl8pPr marL="2889011" indent="0">
              <a:buNone/>
              <a:defRPr sz="1800"/>
            </a:lvl8pPr>
            <a:lvl9pPr marL="3301727" indent="0">
              <a:buNone/>
              <a:defRPr sz="1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8818" y="6440807"/>
            <a:ext cx="3730943" cy="965834"/>
          </a:xfrm>
        </p:spPr>
        <p:txBody>
          <a:bodyPr/>
          <a:lstStyle>
            <a:lvl1pPr marL="0" indent="0">
              <a:buNone/>
              <a:defRPr sz="1300"/>
            </a:lvl1pPr>
            <a:lvl2pPr marL="412716" indent="0">
              <a:buNone/>
              <a:defRPr sz="1100"/>
            </a:lvl2pPr>
            <a:lvl3pPr marL="825432" indent="0">
              <a:buNone/>
              <a:defRPr sz="900"/>
            </a:lvl3pPr>
            <a:lvl4pPr marL="1238148" indent="0">
              <a:buNone/>
              <a:defRPr sz="800"/>
            </a:lvl4pPr>
            <a:lvl5pPr marL="1650864" indent="0">
              <a:buNone/>
              <a:defRPr sz="800"/>
            </a:lvl5pPr>
            <a:lvl6pPr marL="2063581" indent="0">
              <a:buNone/>
              <a:defRPr sz="800"/>
            </a:lvl6pPr>
            <a:lvl7pPr marL="2476296" indent="0">
              <a:buNone/>
              <a:defRPr sz="800"/>
            </a:lvl7pPr>
            <a:lvl8pPr marL="2889011" indent="0">
              <a:buNone/>
              <a:defRPr sz="800"/>
            </a:lvl8pPr>
            <a:lvl9pPr marL="3301727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B974A-4F3C-47B7-94AD-5246A51D4144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46560-B1B3-4A1F-A598-F19E307B53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9495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0912" y="329566"/>
            <a:ext cx="5596414" cy="1371600"/>
          </a:xfrm>
          <a:prstGeom prst="rect">
            <a:avLst/>
          </a:prstGeom>
        </p:spPr>
        <p:txBody>
          <a:bodyPr vert="horz" lIns="82543" tIns="41272" rIns="82543" bIns="41272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0912" y="1920241"/>
            <a:ext cx="5596414" cy="5431156"/>
          </a:xfrm>
          <a:prstGeom prst="rect">
            <a:avLst/>
          </a:prstGeom>
        </p:spPr>
        <p:txBody>
          <a:bodyPr vert="horz" lIns="82543" tIns="41272" rIns="82543" bIns="41272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0912" y="7627622"/>
            <a:ext cx="1450922" cy="438150"/>
          </a:xfrm>
          <a:prstGeom prst="rect">
            <a:avLst/>
          </a:prstGeom>
        </p:spPr>
        <p:txBody>
          <a:bodyPr vert="horz" lIns="82543" tIns="41272" rIns="82543" bIns="41272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BB974A-4F3C-47B7-94AD-5246A51D4144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4565" y="7627622"/>
            <a:ext cx="1969109" cy="438150"/>
          </a:xfrm>
          <a:prstGeom prst="rect">
            <a:avLst/>
          </a:prstGeom>
        </p:spPr>
        <p:txBody>
          <a:bodyPr vert="horz" lIns="82543" tIns="41272" rIns="82543" bIns="41272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56404" y="7627622"/>
            <a:ext cx="1450922" cy="438150"/>
          </a:xfrm>
          <a:prstGeom prst="rect">
            <a:avLst/>
          </a:prstGeom>
        </p:spPr>
        <p:txBody>
          <a:bodyPr vert="horz" lIns="82543" tIns="41272" rIns="82543" bIns="41272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246560-B1B3-4A1F-A598-F19E307B53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440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25432" rtl="0" eaLnBrk="1" latinLnBrk="0" hangingPunct="1"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9538" indent="-309538" algn="l" defTabSz="825432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70663" indent="-257947" algn="l" defTabSz="825432" rtl="0" eaLnBrk="1" latinLnBrk="0" hangingPunct="1">
        <a:spcBef>
          <a:spcPct val="20000"/>
        </a:spcBef>
        <a:buFont typeface="Arial" panose="020B0604020202020204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31789" indent="-206358" algn="l" defTabSz="825432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44505" indent="-206358" algn="l" defTabSz="825432" rtl="0" eaLnBrk="1" latinLnBrk="0" hangingPunct="1">
        <a:spcBef>
          <a:spcPct val="20000"/>
        </a:spcBef>
        <a:buFont typeface="Arial" panose="020B0604020202020204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57222" indent="-206358" algn="l" defTabSz="825432" rtl="0" eaLnBrk="1" latinLnBrk="0" hangingPunct="1">
        <a:spcBef>
          <a:spcPct val="20000"/>
        </a:spcBef>
        <a:buFont typeface="Arial" panose="020B0604020202020204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69938" indent="-206358" algn="l" defTabSz="825432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82654" indent="-206358" algn="l" defTabSz="825432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095370" indent="-206358" algn="l" defTabSz="825432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08086" indent="-206358" algn="l" defTabSz="825432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54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412716" algn="l" defTabSz="8254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825432" algn="l" defTabSz="8254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38148" algn="l" defTabSz="8254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650864" algn="l" defTabSz="8254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2063581" algn="l" defTabSz="8254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476296" algn="l" defTabSz="8254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889011" algn="l" defTabSz="8254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301727" algn="l" defTabSz="8254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2648184"/>
              </p:ext>
            </p:extLst>
          </p:nvPr>
        </p:nvGraphicFramePr>
        <p:xfrm>
          <a:off x="947131" y="1783081"/>
          <a:ext cx="3889278" cy="29646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806" name="Prism 8" r:id="rId3" imgW="3764138" imgH="2890596" progId="Prism8.Document">
                  <p:embed/>
                </p:oleObj>
              </mc:Choice>
              <mc:Fallback>
                <p:oleObj name="Prism 8" r:id="rId3" imgW="3764138" imgH="289059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47131" y="1783081"/>
                        <a:ext cx="3889278" cy="29646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633008" y="4594861"/>
            <a:ext cx="3317018" cy="304691"/>
          </a:xfrm>
          <a:prstGeom prst="rect">
            <a:avLst/>
          </a:prstGeom>
          <a:noFill/>
        </p:spPr>
        <p:txBody>
          <a:bodyPr wrap="none" lIns="82543" tIns="41272" rIns="82543" bIns="41272" rtlCol="0">
            <a:spAutoFit/>
          </a:bodyPr>
          <a:lstStyle/>
          <a:p>
            <a:r>
              <a:rPr lang="en-US" sz="1400" b="1" dirty="0"/>
              <a:t>classical         intermediate    non-classical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07277" y="5074921"/>
            <a:ext cx="5596413" cy="637090"/>
          </a:xfrm>
          <a:prstGeom prst="rect">
            <a:avLst/>
          </a:prstGeom>
          <a:noFill/>
          <a:ln>
            <a:noFill/>
          </a:ln>
        </p:spPr>
        <p:txBody>
          <a:bodyPr wrap="square" lIns="82543" tIns="41272" rIns="82543" bIns="41272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Monocytes were classified as classical (CD1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16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, intermediate (CD1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16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 or non-classical (CD1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16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. Fluorescence was measured using a FACS CANTO II (BD) and analysed with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FlowJo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software. There was no difference in cell number between control (CTL) and DM2+CVD monocyte populations.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4634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2518987"/>
              </p:ext>
            </p:extLst>
          </p:nvPr>
        </p:nvGraphicFramePr>
        <p:xfrm>
          <a:off x="276367" y="2142581"/>
          <a:ext cx="5626213" cy="30009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62" name="Prism 8" r:id="rId3" imgW="6543306" imgH="3515824" progId="Prism8.Document">
                  <p:embed/>
                </p:oleObj>
              </mc:Choice>
              <mc:Fallback>
                <p:oleObj name="Prism 8" r:id="rId3" imgW="6543306" imgH="351582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6367" y="2142581"/>
                        <a:ext cx="5626213" cy="30009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7275" y="5183043"/>
            <a:ext cx="5803689" cy="914347"/>
          </a:xfrm>
          <a:prstGeom prst="rect">
            <a:avLst/>
          </a:prstGeom>
          <a:noFill/>
          <a:ln>
            <a:noFill/>
          </a:ln>
        </p:spPr>
        <p:txBody>
          <a:bodyPr wrap="square" lIns="82543" tIns="41272" rIns="82543" bIns="41272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2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onocytes were stimulated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ex vivo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IFN</a:t>
            </a:r>
            <a:r>
              <a:rPr lang="en-US" sz="900" dirty="0" err="1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(1.5; 3.12; 6.25; 12.5; 25 U/ml), apabetalone (1.5; 3.12; 6.25; 12.5; 25 </a:t>
            </a:r>
            <a:r>
              <a:rPr lang="en-US" sz="900" dirty="0" err="1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 or a combination of both stimuli for 24h. Subsequently, cytotoxicity was determined by measuring the enzyme lactate dehydrogenase (LDH) in the supernatant using the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CytoTox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96 Non-Radioactive Cytotoxicity Assay. There was no difference between ‘unstimulated’ and stimulated conditions, except for the positive control where p&lt;0.0001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tatistics: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ne-Way ANOVA with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Dunnett’s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multiple comparisons test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796380" y="2219581"/>
            <a:ext cx="418370" cy="252627"/>
          </a:xfrm>
          <a:prstGeom prst="rect">
            <a:avLst/>
          </a:prstGeom>
          <a:noFill/>
        </p:spPr>
        <p:txBody>
          <a:bodyPr wrap="none" lIns="82543" tIns="41272" rIns="82543" bIns="41272" rtlCol="0">
            <a:spAutoFit/>
          </a:bodyPr>
          <a:lstStyle/>
          <a:p>
            <a:r>
              <a:rPr lang="en-US" sz="1100" b="1" dirty="0" err="1"/>
              <a:t>IFN</a:t>
            </a:r>
            <a:r>
              <a:rPr lang="en-US" sz="1100" b="1" dirty="0" err="1">
                <a:latin typeface="Symbol" panose="05050102010706020507" pitchFamily="18" charset="2"/>
              </a:rPr>
              <a:t>g</a:t>
            </a:r>
            <a:endParaRPr lang="en-US" sz="1100" b="1" dirty="0">
              <a:latin typeface="Symbol" panose="05050102010706020507" pitchFamily="18" charset="2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189909" y="2219581"/>
            <a:ext cx="1303227" cy="252627"/>
          </a:xfrm>
          <a:prstGeom prst="rect">
            <a:avLst/>
          </a:prstGeom>
          <a:noFill/>
        </p:spPr>
        <p:txBody>
          <a:bodyPr wrap="none" lIns="82543" tIns="41272" rIns="82543" bIns="41272" rtlCol="0">
            <a:spAutoFit/>
          </a:bodyPr>
          <a:lstStyle/>
          <a:p>
            <a:pPr algn="ctr"/>
            <a:r>
              <a:rPr lang="en-US" sz="1100" b="1" dirty="0"/>
              <a:t>Apabetalone + </a:t>
            </a:r>
            <a:r>
              <a:rPr lang="en-US" sz="1100" b="1" dirty="0" err="1"/>
              <a:t>IFN</a:t>
            </a:r>
            <a:r>
              <a:rPr lang="en-US" sz="1100" b="1" dirty="0" err="1">
                <a:latin typeface="Symbol" panose="05050102010706020507" pitchFamily="18" charset="2"/>
              </a:rPr>
              <a:t>g</a:t>
            </a:r>
            <a:endParaRPr lang="en-US" sz="1100" b="1" dirty="0">
              <a:latin typeface="Symbol" panose="05050102010706020507" pitchFamily="18" charset="2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836642" y="2219581"/>
            <a:ext cx="916904" cy="252627"/>
          </a:xfrm>
          <a:prstGeom prst="rect">
            <a:avLst/>
          </a:prstGeom>
          <a:noFill/>
        </p:spPr>
        <p:txBody>
          <a:bodyPr wrap="none" lIns="82543" tIns="41272" rIns="82543" bIns="41272" rtlCol="0">
            <a:spAutoFit/>
          </a:bodyPr>
          <a:lstStyle/>
          <a:p>
            <a:r>
              <a:rPr lang="en-US" sz="1100" b="1" dirty="0"/>
              <a:t>Apabetalone</a:t>
            </a:r>
          </a:p>
        </p:txBody>
      </p:sp>
    </p:spTree>
    <p:extLst>
      <p:ext uri="{BB962C8B-B14F-4D97-AF65-F5344CB8AC3E}">
        <p14:creationId xmlns:p14="http://schemas.microsoft.com/office/powerpoint/2010/main" val="138513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9216167"/>
              </p:ext>
            </p:extLst>
          </p:nvPr>
        </p:nvGraphicFramePr>
        <p:xfrm>
          <a:off x="1674032" y="2331720"/>
          <a:ext cx="2524720" cy="22202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67" name="Prism 8" r:id="rId3" imgW="2579652" imgH="2289859" progId="Prism8.Document">
                  <p:embed/>
                </p:oleObj>
              </mc:Choice>
              <mc:Fallback>
                <p:oleObj name="Prism 8" r:id="rId3" imgW="2579652" imgH="228985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74032" y="2331720"/>
                        <a:ext cx="2524720" cy="22202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2832753" y="2263141"/>
            <a:ext cx="1024305" cy="252627"/>
          </a:xfrm>
          <a:prstGeom prst="rect">
            <a:avLst/>
          </a:prstGeom>
          <a:noFill/>
        </p:spPr>
        <p:txBody>
          <a:bodyPr wrap="none" lIns="82543" tIns="41272" rIns="82543" bIns="41272" rtlCol="0">
            <a:spAutoFit/>
          </a:bodyPr>
          <a:lstStyle/>
          <a:p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BRD4 mRNA</a:t>
            </a:r>
          </a:p>
        </p:txBody>
      </p:sp>
      <p:cxnSp>
        <p:nvCxnSpPr>
          <p:cNvPr id="3" name="Straight Connector 2"/>
          <p:cNvCxnSpPr/>
          <p:nvPr/>
        </p:nvCxnSpPr>
        <p:spPr>
          <a:xfrm>
            <a:off x="2941122" y="2849900"/>
            <a:ext cx="78982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3099745" y="2809103"/>
            <a:ext cx="500123" cy="283405"/>
          </a:xfrm>
          <a:prstGeom prst="rect">
            <a:avLst/>
          </a:prstGeom>
          <a:noFill/>
        </p:spPr>
        <p:txBody>
          <a:bodyPr wrap="none" lIns="82543" tIns="41272" rIns="82543" bIns="41272" rtlCol="0">
            <a:spAutoFit/>
          </a:bodyPr>
          <a:lstStyle/>
          <a:p>
            <a:r>
              <a:rPr lang="en-US" sz="1300" dirty="0"/>
              <a:t>*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642758" y="4414141"/>
            <a:ext cx="589891" cy="252627"/>
          </a:xfrm>
          <a:prstGeom prst="rect">
            <a:avLst/>
          </a:prstGeom>
          <a:noFill/>
        </p:spPr>
        <p:txBody>
          <a:bodyPr wrap="none" lIns="82543" tIns="41272" rIns="82543" bIns="41272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274015" y="4414141"/>
            <a:ext cx="1014687" cy="252627"/>
          </a:xfrm>
          <a:prstGeom prst="rect">
            <a:avLst/>
          </a:prstGeom>
          <a:noFill/>
        </p:spPr>
        <p:txBody>
          <a:bodyPr wrap="none" lIns="82543" tIns="41272" rIns="82543" bIns="41272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pabetalone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07274" y="4846623"/>
            <a:ext cx="5665506" cy="498591"/>
          </a:xfrm>
          <a:prstGeom prst="rect">
            <a:avLst/>
          </a:prstGeom>
          <a:noFill/>
        </p:spPr>
        <p:txBody>
          <a:bodyPr wrap="square" lIns="82543" tIns="41272" rIns="82543" bIns="41272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3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BRD4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mRNA expression is reduced by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ex vivo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reatment with apabetalone in DM2+CVD monocytes (4h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ex vivo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reatment, 25 </a:t>
            </a:r>
            <a:r>
              <a:rPr lang="en-US" sz="900" dirty="0" err="1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BRD4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expression was measured by real time PCR and normalized to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cyclophilin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 (endogenous control)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tatistics: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Unpaired Student’s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test, **** p&lt;0.0001.</a:t>
            </a:r>
          </a:p>
        </p:txBody>
      </p:sp>
    </p:spTree>
    <p:extLst>
      <p:ext uri="{BB962C8B-B14F-4D97-AF65-F5344CB8AC3E}">
        <p14:creationId xmlns:p14="http://schemas.microsoft.com/office/powerpoint/2010/main" val="14192785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727</TotalTime>
  <Words>161</Words>
  <Application>Microsoft Office PowerPoint</Application>
  <PresentationFormat>Custom</PresentationFormat>
  <Paragraphs>11</Paragraphs>
  <Slides>3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Office Theme</vt:lpstr>
      <vt:lpstr>Prism 8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anie Stotz</dc:creator>
  <cp:lastModifiedBy>Sylwia Wasiak</cp:lastModifiedBy>
  <cp:revision>659</cp:revision>
  <cp:lastPrinted>2020-02-11T20:40:51Z</cp:lastPrinted>
  <dcterms:created xsi:type="dcterms:W3CDTF">2019-11-26T17:17:44Z</dcterms:created>
  <dcterms:modified xsi:type="dcterms:W3CDTF">2020-09-29T18:29:00Z</dcterms:modified>
</cp:coreProperties>
</file>